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jpg" ContentType="image/jp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30" d="100"/>
          <a:sy n="130" d="100"/>
        </p:scale>
        <p:origin x="-264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2.jp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2.jpg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Slid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35924" y="966513"/>
            <a:ext cx="8072150" cy="3911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840480"/>
            <a:ext cx="64008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1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1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1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Relationship Id="rId7" Type="http://schemas.openxmlformats.org/officeDocument/2006/relationships/image" Target="../media/image1.jpg"/><Relationship Id="rId8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9143999" cy="685799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5924" y="869675"/>
            <a:ext cx="8072150" cy="3911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1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764524" y="1784075"/>
            <a:ext cx="7614950" cy="221424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0" i="0">
                <a:solidFill>
                  <a:srgbClr val="00447C"/>
                </a:solidFill>
                <a:latin typeface="Verdana"/>
                <a:cs typeface="Verdana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6377940"/>
            <a:ext cx="292608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3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58368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hyperlink" Target="mailto:hs-capr@ucdavis.edu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4.png"/><Relationship Id="rId5" Type="http://schemas.openxmlformats.org/officeDocument/2006/relationships/hyperlink" Target="http://www.istockphoto.com/portfolio/bowdenimages" TargetMode="Externa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5.png"/><Relationship Id="rId5" Type="http://schemas.openxmlformats.org/officeDocument/2006/relationships/hyperlink" Target="http://www.istockphoto.com/portfolio/bowdenimages" TargetMode="Externa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1457102" y="4603475"/>
            <a:ext cx="6229985" cy="751205"/>
          </a:xfrm>
          <a:prstGeom prst="rect">
            <a:avLst/>
          </a:prstGeom>
        </p:spPr>
        <p:txBody>
          <a:bodyPr vert="horz" wrap="square" lIns="0" tIns="29845" rIns="0" bIns="0" rtlCol="0">
            <a:spAutoFit/>
          </a:bodyPr>
          <a:lstStyle/>
          <a:p>
            <a:pPr marL="844550" marR="5080" indent="-832485">
              <a:lnSpc>
                <a:spcPts val="2830"/>
              </a:lnSpc>
              <a:spcBef>
                <a:spcPts val="235"/>
              </a:spcBef>
            </a:pPr>
            <a:r>
              <a:rPr sz="2400" b="1" spc="-5" dirty="0">
                <a:solidFill>
                  <a:srgbClr val="00447C"/>
                </a:solidFill>
                <a:latin typeface="Verdana"/>
                <a:cs typeface="Verdana"/>
              </a:rPr>
              <a:t>Cancer Pain and Treatment Options:  Gerald Dubois Return</a:t>
            </a:r>
            <a:r>
              <a:rPr sz="2400" b="1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b="1" spc="-5" dirty="0">
                <a:solidFill>
                  <a:srgbClr val="00447C"/>
                </a:solidFill>
                <a:latin typeface="Verdana"/>
                <a:cs typeface="Verdana"/>
              </a:rPr>
              <a:t>Visit</a:t>
            </a:r>
            <a:endParaRPr sz="2400">
              <a:latin typeface="Verdana"/>
              <a:cs typeface="Verdan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12124" y="1089131"/>
            <a:ext cx="7773034" cy="5511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46685" algn="ctr">
              <a:lnSpc>
                <a:spcPct val="100000"/>
              </a:lnSpc>
              <a:spcBef>
                <a:spcPts val="100"/>
              </a:spcBef>
            </a:pP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Use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of</a:t>
            </a:r>
            <a:r>
              <a:rPr sz="2400" spc="-85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Material</a:t>
            </a:r>
            <a:endParaRPr sz="24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2500">
              <a:latin typeface="Times New Roman"/>
              <a:cs typeface="Times New Roman"/>
            </a:endParaRPr>
          </a:p>
          <a:p>
            <a:pPr marL="12700" marR="188595">
              <a:lnSpc>
                <a:spcPct val="100000"/>
              </a:lnSpc>
              <a:tabLst>
                <a:tab pos="850265" algn="l"/>
                <a:tab pos="3347085" algn="l"/>
              </a:tabLst>
            </a:pP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© </a:t>
            </a: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The Regents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of the </a:t>
            </a: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University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of </a:t>
            </a: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California, Davis campus, 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2016.	</a:t>
            </a: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All</a:t>
            </a:r>
            <a:r>
              <a:rPr sz="2400" spc="5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spc="-5" dirty="0">
                <a:solidFill>
                  <a:srgbClr val="003278"/>
                </a:solidFill>
                <a:latin typeface="Times New Roman"/>
                <a:cs typeface="Times New Roman"/>
              </a:rPr>
              <a:t>rights reserved.	For information</a:t>
            </a:r>
            <a:r>
              <a:rPr sz="2400" spc="-45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contact</a:t>
            </a:r>
            <a:r>
              <a:rPr sz="2400" spc="-45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u="heavy" spc="-5" dirty="0">
                <a:solidFill>
                  <a:srgbClr val="0000FF"/>
                </a:solidFill>
                <a:latin typeface="Times New Roman"/>
                <a:cs typeface="Times New Roman"/>
                <a:hlinkClick r:id="rId2"/>
              </a:rPr>
              <a:t>hs- </a:t>
            </a:r>
            <a:r>
              <a:rPr sz="2400" spc="-5" dirty="0">
                <a:solidFill>
                  <a:srgbClr val="0000FF"/>
                </a:solidFill>
                <a:latin typeface="Times New Roman"/>
                <a:cs typeface="Times New Roman"/>
              </a:rPr>
              <a:t> </a:t>
            </a:r>
            <a:r>
              <a:rPr sz="2400" u="heavy" spc="-5" dirty="0">
                <a:solidFill>
                  <a:srgbClr val="0000FF"/>
                </a:solidFill>
                <a:latin typeface="Times New Roman"/>
                <a:cs typeface="Times New Roman"/>
                <a:hlinkClick r:id="rId2"/>
              </a:rPr>
              <a:t>capr@ucdavis.edu</a:t>
            </a:r>
            <a:r>
              <a:rPr sz="2400" spc="-5" dirty="0">
                <a:solidFill>
                  <a:srgbClr val="0000FF"/>
                </a:solidFill>
                <a:latin typeface="Times New Roman"/>
                <a:cs typeface="Times New Roman"/>
                <a:hlinkClick r:id="rId2"/>
              </a:rPr>
              <a:t>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or (916)</a:t>
            </a:r>
            <a:r>
              <a:rPr sz="2400" spc="-70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dirty="0">
                <a:solidFill>
                  <a:srgbClr val="003278"/>
                </a:solidFill>
                <a:latin typeface="Times New Roman"/>
                <a:cs typeface="Times New Roman"/>
              </a:rPr>
              <a:t>734-2145.</a:t>
            </a:r>
            <a:endParaRPr sz="24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2500">
              <a:latin typeface="Times New Roman"/>
              <a:cs typeface="Times New Roman"/>
            </a:endParaRPr>
          </a:p>
          <a:p>
            <a:pPr marL="12700" marR="5080">
              <a:lnSpc>
                <a:spcPct val="100000"/>
              </a:lnSpc>
            </a:pP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This material may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be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reproduced, distributed,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publicly 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displayed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and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modified provided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that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attribution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to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UC Davis 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School of Medicine and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Betty Irene Moore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School of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Nursing</a:t>
            </a:r>
            <a:r>
              <a:rPr sz="2400" i="1" spc="-85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is  clearly stated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and it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is used for non-commercial purposes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only. 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Please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contact </a:t>
            </a:r>
            <a:r>
              <a:rPr sz="2400" i="1" u="heavy" spc="-5" dirty="0">
                <a:solidFill>
                  <a:srgbClr val="0000FF"/>
                </a:solidFill>
                <a:latin typeface="Times New Roman"/>
                <a:cs typeface="Times New Roman"/>
                <a:hlinkClick r:id="rId2"/>
              </a:rPr>
              <a:t>hs-capr@ucdavis.edu</a:t>
            </a:r>
            <a:r>
              <a:rPr sz="2400" i="1" spc="-5" dirty="0">
                <a:solidFill>
                  <a:srgbClr val="0000FF"/>
                </a:solidFill>
                <a:latin typeface="Times New Roman"/>
                <a:cs typeface="Times New Roman"/>
                <a:hlinkClick r:id="rId2"/>
              </a:rPr>
              <a:t>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for permission for other  use.</a:t>
            </a:r>
            <a:endParaRPr sz="24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2500">
              <a:latin typeface="Times New Roman"/>
              <a:cs typeface="Times New Roman"/>
            </a:endParaRPr>
          </a:p>
          <a:p>
            <a:pPr marL="12700" marR="423545">
              <a:lnSpc>
                <a:spcPct val="100000"/>
              </a:lnSpc>
            </a:pP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The photos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cannot be copied and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reused for other purposes, 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including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development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of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other </a:t>
            </a:r>
            <a:r>
              <a:rPr sz="2400" i="1" dirty="0">
                <a:solidFill>
                  <a:srgbClr val="003278"/>
                </a:solidFill>
                <a:latin typeface="Times New Roman"/>
                <a:cs typeface="Times New Roman"/>
              </a:rPr>
              <a:t>educational</a:t>
            </a:r>
            <a:r>
              <a:rPr sz="2400" i="1" spc="-80" dirty="0">
                <a:solidFill>
                  <a:srgbClr val="003278"/>
                </a:solidFill>
                <a:latin typeface="Times New Roman"/>
                <a:cs typeface="Times New Roman"/>
              </a:rPr>
              <a:t> </a:t>
            </a:r>
            <a:r>
              <a:rPr sz="2400" i="1" spc="-5" dirty="0">
                <a:solidFill>
                  <a:srgbClr val="003278"/>
                </a:solidFill>
                <a:latin typeface="Times New Roman"/>
                <a:cs typeface="Times New Roman"/>
              </a:rPr>
              <a:t>material.</a:t>
            </a:r>
            <a:endParaRPr sz="24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0"/>
            <a:ext cx="9143999" cy="685799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0" y="1306512"/>
            <a:ext cx="4049711" cy="4868354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 txBox="1"/>
          <p:nvPr/>
        </p:nvSpPr>
        <p:spPr>
          <a:xfrm>
            <a:off x="4192000" y="2133960"/>
            <a:ext cx="4172585" cy="331152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>
              <a:lnSpc>
                <a:spcPct val="99800"/>
              </a:lnSpc>
              <a:spcBef>
                <a:spcPts val="105"/>
              </a:spcBef>
              <a:tabLst>
                <a:tab pos="1778635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Gerald reports that his  pain is somewhat  improved.	His</a:t>
            </a:r>
            <a:r>
              <a:rPr sz="2400" spc="-2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wife</a:t>
            </a:r>
            <a:r>
              <a:rPr sz="2400" spc="-3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says </a:t>
            </a: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she was glad when </a:t>
            </a: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he 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recently made the effort to  attend his grandson’s  birthday party, even  though he wanted to leave  early.</a:t>
            </a:r>
            <a:endParaRPr sz="2400">
              <a:latin typeface="Verdana"/>
              <a:cs typeface="Verdana"/>
            </a:endParaRPr>
          </a:p>
        </p:txBody>
      </p:sp>
      <p:sp>
        <p:nvSpPr>
          <p:cNvPr id="6" name="object 6"/>
          <p:cNvSpPr txBox="1">
            <a:spLocks noGrp="1"/>
          </p:cNvSpPr>
          <p:nvPr>
            <p:ph type="title"/>
          </p:nvPr>
        </p:nvSpPr>
        <p:spPr>
          <a:xfrm>
            <a:off x="535924" y="869650"/>
            <a:ext cx="5748655" cy="751205"/>
          </a:xfrm>
          <a:prstGeom prst="rect">
            <a:avLst/>
          </a:prstGeom>
        </p:spPr>
        <p:txBody>
          <a:bodyPr vert="horz" wrap="square" lIns="0" tIns="29845" rIns="0" bIns="0" rtlCol="0">
            <a:spAutoFit/>
          </a:bodyPr>
          <a:lstStyle/>
          <a:p>
            <a:pPr marL="12700" marR="5080">
              <a:lnSpc>
                <a:spcPts val="2830"/>
              </a:lnSpc>
              <a:spcBef>
                <a:spcPts val="235"/>
              </a:spcBef>
            </a:pPr>
            <a:r>
              <a:rPr spc="-5" dirty="0"/>
              <a:t>Six-week follow-up appointment:  Gerald’s</a:t>
            </a:r>
            <a:r>
              <a:rPr spc="-55" dirty="0"/>
              <a:t> </a:t>
            </a:r>
            <a:r>
              <a:rPr spc="-5" dirty="0"/>
              <a:t>status</a:t>
            </a:r>
          </a:p>
        </p:txBody>
      </p:sp>
      <p:sp>
        <p:nvSpPr>
          <p:cNvPr id="7" name="object 7"/>
          <p:cNvSpPr txBox="1"/>
          <p:nvPr/>
        </p:nvSpPr>
        <p:spPr>
          <a:xfrm>
            <a:off x="459724" y="6060927"/>
            <a:ext cx="1543050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5" dirty="0">
                <a:solidFill>
                  <a:srgbClr val="003278"/>
                </a:solidFill>
                <a:latin typeface="Times New Roman"/>
                <a:cs typeface="Times New Roman"/>
              </a:rPr>
              <a:t>©iStock.com/</a:t>
            </a:r>
            <a:r>
              <a:rPr sz="1100" u="sng" spc="-5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Cathy</a:t>
            </a:r>
            <a:r>
              <a:rPr sz="1100" u="sng" spc="-60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 </a:t>
            </a:r>
            <a:r>
              <a:rPr sz="1100" u="sng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Yeulet</a:t>
            </a:r>
            <a:endParaRPr sz="11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0"/>
            <a:ext cx="9143999" cy="685799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0" y="0"/>
            <a:ext cx="9144000" cy="678941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0" y="3101975"/>
            <a:ext cx="9144000" cy="3415283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 txBox="1">
            <a:spLocks noGrp="1"/>
          </p:cNvSpPr>
          <p:nvPr>
            <p:ph type="title"/>
          </p:nvPr>
        </p:nvSpPr>
        <p:spPr>
          <a:xfrm>
            <a:off x="535924" y="863579"/>
            <a:ext cx="25952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-5" dirty="0"/>
              <a:t>Gerald’s</a:t>
            </a:r>
            <a:r>
              <a:rPr spc="-55" dirty="0"/>
              <a:t> </a:t>
            </a:r>
            <a:r>
              <a:rPr spc="-5" dirty="0"/>
              <a:t>status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>
              <a:lnSpc>
                <a:spcPct val="99700"/>
              </a:lnSpc>
              <a:spcBef>
                <a:spcPts val="105"/>
              </a:spcBef>
            </a:pPr>
            <a:r>
              <a:rPr spc="-5" dirty="0"/>
              <a:t>Despite this modest improvement in pain, </a:t>
            </a:r>
            <a:r>
              <a:rPr dirty="0"/>
              <a:t>he </a:t>
            </a:r>
            <a:r>
              <a:rPr spc="-5" dirty="0"/>
              <a:t>is  still sleeping poorly and says </a:t>
            </a:r>
            <a:r>
              <a:rPr dirty="0"/>
              <a:t>he </a:t>
            </a:r>
            <a:r>
              <a:rPr spc="-5" dirty="0"/>
              <a:t>is still frequently  constipated. His wife says that </a:t>
            </a:r>
            <a:r>
              <a:rPr dirty="0"/>
              <a:t>the </a:t>
            </a:r>
            <a:r>
              <a:rPr spc="-5" dirty="0"/>
              <a:t>visit with his  grandson was the exception—most of </a:t>
            </a:r>
            <a:r>
              <a:rPr dirty="0"/>
              <a:t>the </a:t>
            </a:r>
            <a:r>
              <a:rPr spc="-5" dirty="0"/>
              <a:t>time  Gerald prefers to stay at home reading, watching  television, and</a:t>
            </a:r>
            <a:r>
              <a:rPr spc="40" dirty="0"/>
              <a:t> </a:t>
            </a:r>
            <a:r>
              <a:rPr spc="-5" dirty="0"/>
              <a:t>napping.</a:t>
            </a:r>
          </a:p>
        </p:txBody>
      </p:sp>
      <p:sp>
        <p:nvSpPr>
          <p:cNvPr id="7" name="object 7"/>
          <p:cNvSpPr txBox="1"/>
          <p:nvPr/>
        </p:nvSpPr>
        <p:spPr>
          <a:xfrm>
            <a:off x="5031724" y="6537177"/>
            <a:ext cx="1543050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5" dirty="0">
                <a:solidFill>
                  <a:srgbClr val="003278"/>
                </a:solidFill>
                <a:latin typeface="Times New Roman"/>
                <a:cs typeface="Times New Roman"/>
              </a:rPr>
              <a:t>©iStock.com/</a:t>
            </a:r>
            <a:r>
              <a:rPr sz="1100" u="sng" spc="-5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Cathy</a:t>
            </a:r>
            <a:r>
              <a:rPr sz="1100" u="sng" spc="-60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 </a:t>
            </a:r>
            <a:r>
              <a:rPr sz="1100" u="sng" dirty="0">
                <a:solidFill>
                  <a:srgbClr val="0000FF"/>
                </a:solidFill>
                <a:latin typeface="Times New Roman"/>
                <a:cs typeface="Times New Roman"/>
                <a:hlinkClick r:id="rId5"/>
              </a:rPr>
              <a:t>Yeulet</a:t>
            </a:r>
            <a:endParaRPr sz="11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35924" y="966513"/>
            <a:ext cx="475869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b="1" spc="-5" dirty="0">
                <a:solidFill>
                  <a:srgbClr val="00447C"/>
                </a:solidFill>
                <a:latin typeface="Verdana"/>
                <a:cs typeface="Verdana"/>
              </a:rPr>
              <a:t>Treatment Plan</a:t>
            </a:r>
            <a:r>
              <a:rPr sz="2400" b="1" spc="-2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b="1" spc="-5" dirty="0">
                <a:solidFill>
                  <a:srgbClr val="00447C"/>
                </a:solidFill>
                <a:latin typeface="Verdana"/>
                <a:cs typeface="Verdana"/>
              </a:rPr>
              <a:t>Adjustment</a:t>
            </a:r>
            <a:endParaRPr sz="2400">
              <a:latin typeface="Verdana"/>
              <a:cs typeface="Verdana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535670" y="1977814"/>
            <a:ext cx="7419975" cy="941069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5"/>
              </a:spcBef>
            </a:pP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Based on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what we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know about Gerald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and the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new 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information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presented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in his six-week follow-up visit,</a:t>
            </a:r>
            <a:r>
              <a:rPr sz="2000" i="1" spc="-22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how  would you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adjust </a:t>
            </a:r>
            <a:r>
              <a:rPr sz="2000" i="1" dirty="0">
                <a:solidFill>
                  <a:srgbClr val="00447C"/>
                </a:solidFill>
                <a:latin typeface="Verdana"/>
                <a:cs typeface="Verdana"/>
              </a:rPr>
              <a:t>the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care</a:t>
            </a:r>
            <a:r>
              <a:rPr sz="2000" i="1" spc="-130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000" i="1" spc="-5" dirty="0">
                <a:solidFill>
                  <a:srgbClr val="00447C"/>
                </a:solidFill>
                <a:latin typeface="Verdana"/>
                <a:cs typeface="Verdana"/>
              </a:rPr>
              <a:t>plan?</a:t>
            </a:r>
            <a:endParaRPr sz="2000">
              <a:latin typeface="Verdana"/>
              <a:cs typeface="Verdana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2293778" y="2840207"/>
            <a:ext cx="4556125" cy="6350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4000" spc="-10" dirty="0"/>
              <a:t>Final</a:t>
            </a:r>
            <a:r>
              <a:rPr sz="4000" spc="-50" dirty="0"/>
              <a:t> </a:t>
            </a:r>
            <a:r>
              <a:rPr sz="4000" spc="-5" dirty="0"/>
              <a:t>discussion</a:t>
            </a:r>
            <a:endParaRPr sz="400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535924" y="869675"/>
            <a:ext cx="362077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-5" dirty="0"/>
              <a:t>Discussion</a:t>
            </a:r>
            <a:r>
              <a:rPr spc="-35" dirty="0"/>
              <a:t> </a:t>
            </a:r>
            <a:r>
              <a:rPr spc="-5" dirty="0"/>
              <a:t>question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535924" y="2012675"/>
            <a:ext cx="8013700" cy="39116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39395" marR="1477010" indent="-226695">
              <a:lnSpc>
                <a:spcPct val="100000"/>
              </a:lnSpc>
              <a:spcBef>
                <a:spcPts val="100"/>
              </a:spcBef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Are there other pharmacological or non-  pharmacological choices outside of those  presented</a:t>
            </a:r>
            <a:r>
              <a:rPr sz="2400" spc="-60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here?</a:t>
            </a:r>
            <a:endParaRPr sz="2400">
              <a:latin typeface="Verdana"/>
              <a:cs typeface="Verdana"/>
            </a:endParaRPr>
          </a:p>
          <a:p>
            <a:pPr marL="239395" marR="1210945" indent="-226695">
              <a:lnSpc>
                <a:spcPct val="100000"/>
              </a:lnSpc>
              <a:spcBef>
                <a:spcPts val="600"/>
              </a:spcBef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What role does each profession play in the  management of Gerald’s</a:t>
            </a:r>
            <a:r>
              <a:rPr sz="2400" spc="3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plan?</a:t>
            </a:r>
            <a:endParaRPr sz="2400">
              <a:latin typeface="Verdana"/>
              <a:cs typeface="Verdana"/>
            </a:endParaRPr>
          </a:p>
          <a:p>
            <a:pPr marL="239395" marR="956944" indent="-226695">
              <a:lnSpc>
                <a:spcPct val="100000"/>
              </a:lnSpc>
              <a:spcBef>
                <a:spcPts val="600"/>
              </a:spcBef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How </a:t>
            </a: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do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you integrate the patient and family  members in the care</a:t>
            </a:r>
            <a:r>
              <a:rPr sz="2400" spc="0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team?</a:t>
            </a:r>
            <a:endParaRPr sz="2400">
              <a:latin typeface="Verdana"/>
              <a:cs typeface="Verdana"/>
            </a:endParaRPr>
          </a:p>
          <a:p>
            <a:pPr marL="239395" marR="5080" indent="-226695">
              <a:lnSpc>
                <a:spcPct val="100000"/>
              </a:lnSpc>
              <a:spcBef>
                <a:spcPts val="600"/>
              </a:spcBef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What are some clinical pearls that you’ve  identified that will help you approach developing a  care plan in such </a:t>
            </a: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a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complex</a:t>
            </a:r>
            <a:r>
              <a:rPr sz="2400" spc="5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10" dirty="0">
                <a:solidFill>
                  <a:srgbClr val="00447C"/>
                </a:solidFill>
                <a:latin typeface="Verdana"/>
                <a:cs typeface="Verdana"/>
              </a:rPr>
              <a:t>case?</a:t>
            </a:r>
            <a:endParaRPr sz="2400">
              <a:latin typeface="Verdana"/>
              <a:cs typeface="Verdana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2363882" y="2687807"/>
            <a:ext cx="4109720" cy="6350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4000" spc="-5" dirty="0">
                <a:solidFill>
                  <a:srgbClr val="003278"/>
                </a:solidFill>
              </a:rPr>
              <a:t>Session</a:t>
            </a:r>
            <a:r>
              <a:rPr sz="4000" spc="-75" dirty="0">
                <a:solidFill>
                  <a:srgbClr val="003278"/>
                </a:solidFill>
              </a:rPr>
              <a:t> </a:t>
            </a:r>
            <a:r>
              <a:rPr sz="4000" spc="-10" dirty="0">
                <a:solidFill>
                  <a:srgbClr val="003278"/>
                </a:solidFill>
              </a:rPr>
              <a:t>Recap</a:t>
            </a:r>
            <a:endParaRPr sz="400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535924" y="869675"/>
            <a:ext cx="24809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-5" dirty="0"/>
              <a:t>Session</a:t>
            </a:r>
            <a:r>
              <a:rPr spc="-55" dirty="0"/>
              <a:t> </a:t>
            </a:r>
            <a:r>
              <a:rPr spc="-5" dirty="0"/>
              <a:t>Recap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535924" y="2012675"/>
            <a:ext cx="8022590" cy="398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39395" marR="539750" indent="-226695">
              <a:lnSpc>
                <a:spcPct val="100000"/>
              </a:lnSpc>
              <a:spcBef>
                <a:spcPts val="100"/>
              </a:spcBef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Treatment decisions should be guided by a  comprehensive pain management plan that  includes perspectives from an interprofessional  team, as well as the patient and</a:t>
            </a:r>
            <a:r>
              <a:rPr sz="2400" spc="7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family.</a:t>
            </a:r>
            <a:endParaRPr sz="2400">
              <a:latin typeface="Verdana"/>
              <a:cs typeface="Verdana"/>
            </a:endParaRPr>
          </a:p>
          <a:p>
            <a:pPr>
              <a:lnSpc>
                <a:spcPct val="100000"/>
              </a:lnSpc>
              <a:spcBef>
                <a:spcPts val="55"/>
              </a:spcBef>
              <a:buClr>
                <a:srgbClr val="B1D2FF"/>
              </a:buClr>
              <a:buFont typeface="Arial"/>
              <a:buChar char="▪"/>
            </a:pPr>
            <a:endParaRPr sz="3500">
              <a:latin typeface="Times New Roman"/>
              <a:cs typeface="Times New Roman"/>
            </a:endParaRPr>
          </a:p>
          <a:p>
            <a:pPr marL="239395" marR="5080" indent="-226695">
              <a:lnSpc>
                <a:spcPct val="100000"/>
              </a:lnSpc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A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wide range of drug and non-drug options can </a:t>
            </a:r>
            <a:r>
              <a:rPr sz="2400" dirty="0">
                <a:solidFill>
                  <a:srgbClr val="00447C"/>
                </a:solidFill>
                <a:latin typeface="Verdana"/>
                <a:cs typeface="Verdana"/>
              </a:rPr>
              <a:t>be 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deployed to treat/manage chronic</a:t>
            </a:r>
            <a:r>
              <a:rPr sz="2400" spc="100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pain.</a:t>
            </a:r>
            <a:endParaRPr sz="2400">
              <a:latin typeface="Verdana"/>
              <a:cs typeface="Verdana"/>
            </a:endParaRPr>
          </a:p>
          <a:p>
            <a:pPr>
              <a:lnSpc>
                <a:spcPct val="100000"/>
              </a:lnSpc>
              <a:spcBef>
                <a:spcPts val="55"/>
              </a:spcBef>
              <a:buClr>
                <a:srgbClr val="B1D2FF"/>
              </a:buClr>
              <a:buFont typeface="Arial"/>
              <a:buChar char="▪"/>
            </a:pPr>
            <a:endParaRPr sz="3500">
              <a:latin typeface="Times New Roman"/>
              <a:cs typeface="Times New Roman"/>
            </a:endParaRPr>
          </a:p>
          <a:p>
            <a:pPr marL="239395" marR="340995" indent="-226695">
              <a:lnSpc>
                <a:spcPct val="100000"/>
              </a:lnSpc>
              <a:buClr>
                <a:srgbClr val="B1D2FF"/>
              </a:buClr>
              <a:buFont typeface="Arial"/>
              <a:buChar char="▪"/>
              <a:tabLst>
                <a:tab pos="240029" algn="l"/>
              </a:tabLst>
            </a:pP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Monitor patients to assess their progress toward  functional goals, and adjust care as</a:t>
            </a:r>
            <a:r>
              <a:rPr sz="2400" spc="135" dirty="0">
                <a:solidFill>
                  <a:srgbClr val="00447C"/>
                </a:solidFill>
                <a:latin typeface="Verdana"/>
                <a:cs typeface="Verdana"/>
              </a:rPr>
              <a:t> </a:t>
            </a:r>
            <a:r>
              <a:rPr sz="2400" spc="-5" dirty="0">
                <a:solidFill>
                  <a:srgbClr val="00447C"/>
                </a:solidFill>
                <a:latin typeface="Verdana"/>
                <a:cs typeface="Verdana"/>
              </a:rPr>
              <a:t>needed.</a:t>
            </a:r>
            <a:endParaRPr sz="2400">
              <a:latin typeface="Verdana"/>
              <a:cs typeface="Verdan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278</Words>
  <Application>Microsoft Macintosh PowerPoint</Application>
  <PresentationFormat>On-screen Show (4:3)</PresentationFormat>
  <Paragraphs>2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Six-week follow-up appointment:  Gerald’s status</vt:lpstr>
      <vt:lpstr>Gerald’s status</vt:lpstr>
      <vt:lpstr>PowerPoint Presentation</vt:lpstr>
      <vt:lpstr>Final discussion</vt:lpstr>
      <vt:lpstr>Discussion questions</vt:lpstr>
      <vt:lpstr>Session Recap</vt:lpstr>
      <vt:lpstr>Session Recap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le:///C:/Users/cchung1/Desktop/Cancer%20Pain%20and%20Treatment%20Options-Facilitators%20Guide.pdf</dc:title>
  <dc:creator>Eric Wilkerson</dc:creator>
  <cp:lastModifiedBy>SMF</cp:lastModifiedBy>
  <cp:revision>1</cp:revision>
  <dcterms:created xsi:type="dcterms:W3CDTF">2020-02-03T15:46:18Z</dcterms:created>
  <dcterms:modified xsi:type="dcterms:W3CDTF">2020-02-03T23:5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06-19T00:00:00Z</vt:filetime>
  </property>
  <property fmtid="{D5CDD505-2E9C-101B-9397-08002B2CF9AE}" pid="3" name="Creator">
    <vt:lpwstr>Adobe Acrobat Pro DC 15.6.30417</vt:lpwstr>
  </property>
  <property fmtid="{D5CDD505-2E9C-101B-9397-08002B2CF9AE}" pid="4" name="LastSaved">
    <vt:filetime>2020-02-03T00:00:00Z</vt:filetime>
  </property>
</Properties>
</file>